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797675" cy="9926638"/>
  <p:custDataLst>
    <p:tags r:id="rId4"/>
  </p:custDataLst>
  <p:defaultTextStyle>
    <a:defPPr>
      <a:defRPr lang="de-DE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1644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tags" Target="tags/tag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cs typeface="Arial" charset="0"/>
              </a:defRPr>
            </a:lvl1pPr>
          </a:lstStyle>
          <a:p>
            <a:pPr>
              <a:defRPr/>
            </a:pPr>
            <a:fld id="{B49C56FE-0D9C-C74B-A2DD-6CC496BDED3F}" type="datetimeFigureOut">
              <a:rPr lang="de-CH"/>
              <a:pPr>
                <a:defRPr/>
              </a:pPr>
              <a:t>07.01.2015</a:t>
            </a:fld>
            <a:endParaRPr lang="de-CH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de-CH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14875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de-CH" noProof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cs typeface="Arial" charset="0"/>
              </a:defRPr>
            </a:lvl1pPr>
          </a:lstStyle>
          <a:p>
            <a:pPr>
              <a:defRPr/>
            </a:pPr>
            <a:fld id="{616D9032-4B03-7849-B82F-EA6A7A8C379E}" type="slidenum">
              <a:rPr lang="de-CH"/>
              <a:pPr>
                <a:defRPr/>
              </a:pPr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857256017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ＭＳ Ｐゴシック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53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</p:sp>
      <p:sp>
        <p:nvSpPr>
          <p:cNvPr id="23554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de-CH">
              <a:latin typeface="Calibri" charset="0"/>
            </a:endParaRPr>
          </a:p>
        </p:txBody>
      </p:sp>
      <p:sp>
        <p:nvSpPr>
          <p:cNvPr id="23555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eaLnBrk="1" hangingPunct="1"/>
            <a:fld id="{A165BA1D-DFAA-814F-BE3C-CA2AB3896005}" type="slidenum">
              <a:rPr lang="de-CH" sz="1200"/>
              <a:pPr eaLnBrk="1" hangingPunct="1"/>
              <a:t>1</a:t>
            </a:fld>
            <a:endParaRPr lang="de-CH" sz="1200"/>
          </a:p>
        </p:txBody>
      </p:sp>
    </p:spTree>
    <p:extLst>
      <p:ext uri="{BB962C8B-B14F-4D97-AF65-F5344CB8AC3E}">
        <p14:creationId xmlns:p14="http://schemas.microsoft.com/office/powerpoint/2010/main" val="27645991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21C1C8E-384F-FB4C-9A9E-E059F7E96B33}" type="datetimeFigureOut">
              <a:rPr lang="de-CH"/>
              <a:pPr>
                <a:defRPr/>
              </a:pPr>
              <a:t>07.01.201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53153CD-BA0F-6B46-8135-123D674FB7A7}" type="slidenum">
              <a:rPr lang="de-CH"/>
              <a:pPr>
                <a:defRPr/>
              </a:pPr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3824907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2F6D5AE-A47D-3044-B603-891790B57F59}" type="datetimeFigureOut">
              <a:rPr lang="de-CH"/>
              <a:pPr>
                <a:defRPr/>
              </a:pPr>
              <a:t>07.01.201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67AB28-6438-C844-A641-8705107B422B}" type="slidenum">
              <a:rPr lang="de-CH"/>
              <a:pPr>
                <a:defRPr/>
              </a:pPr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585987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33B5872-BB9F-F84C-AB4C-CAAD534B4841}" type="datetimeFigureOut">
              <a:rPr lang="de-CH"/>
              <a:pPr>
                <a:defRPr/>
              </a:pPr>
              <a:t>07.01.201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3AEFD1-7CFA-5948-B71D-DEEE28BF25C0}" type="slidenum">
              <a:rPr lang="de-CH"/>
              <a:pPr>
                <a:defRPr/>
              </a:pPr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2086311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E4BC49-C48D-E44D-B212-B6CB2B09C659}" type="datetimeFigureOut">
              <a:rPr lang="de-CH"/>
              <a:pPr>
                <a:defRPr/>
              </a:pPr>
              <a:t>07.01.201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D1919C3-4306-C747-B22D-9E96978FFB52}" type="slidenum">
              <a:rPr lang="de-CH"/>
              <a:pPr>
                <a:defRPr/>
              </a:pPr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9929805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E5E76AF-F1AA-D446-89E8-2ADDD53A6E6B}" type="datetimeFigureOut">
              <a:rPr lang="de-CH"/>
              <a:pPr>
                <a:defRPr/>
              </a:pPr>
              <a:t>07.01.201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DF941B9-992A-2D41-BA84-9E2D1A7DCE26}" type="slidenum">
              <a:rPr lang="de-CH"/>
              <a:pPr>
                <a:defRPr/>
              </a:pPr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661783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9C9370-E80C-D441-8247-7CE50B4B2E73}" type="datetimeFigureOut">
              <a:rPr lang="de-CH"/>
              <a:pPr>
                <a:defRPr/>
              </a:pPr>
              <a:t>07.01.2015</a:t>
            </a:fld>
            <a:endParaRPr lang="de-CH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DA5EA46-6987-B94A-BA7E-98400704A7D6}" type="slidenum">
              <a:rPr lang="de-CH"/>
              <a:pPr>
                <a:defRPr/>
              </a:pPr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3781485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88F0F4C-1475-B240-AA26-B28A2A80C79A}" type="datetimeFigureOut">
              <a:rPr lang="de-CH"/>
              <a:pPr>
                <a:defRPr/>
              </a:pPr>
              <a:t>07.01.2015</a:t>
            </a:fld>
            <a:endParaRPr lang="de-CH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75C44C-1BA0-9642-B9C9-41D1EA2B7C2D}" type="slidenum">
              <a:rPr lang="de-CH"/>
              <a:pPr>
                <a:defRPr/>
              </a:pPr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7676757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3BDB38A-F1C9-F946-8992-58F11ACB9F18}" type="datetimeFigureOut">
              <a:rPr lang="de-CH"/>
              <a:pPr>
                <a:defRPr/>
              </a:pPr>
              <a:t>07.01.2015</a:t>
            </a:fld>
            <a:endParaRPr lang="de-CH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F48D48-BCB5-4C48-B7F4-9305BB294C7C}" type="slidenum">
              <a:rPr lang="de-CH"/>
              <a:pPr>
                <a:defRPr/>
              </a:pPr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5702933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B2D19FF-5C62-7444-BAB7-9B156A852F07}" type="datetimeFigureOut">
              <a:rPr lang="de-CH"/>
              <a:pPr>
                <a:defRPr/>
              </a:pPr>
              <a:t>07.01.2015</a:t>
            </a:fld>
            <a:endParaRPr lang="de-CH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AB3927-CEAE-D540-9357-88951B19E49A}" type="slidenum">
              <a:rPr lang="de-CH"/>
              <a:pPr>
                <a:defRPr/>
              </a:pPr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6745378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D56233D-16E9-2D44-AED2-9B89C14005BD}" type="datetimeFigureOut">
              <a:rPr lang="de-CH"/>
              <a:pPr>
                <a:defRPr/>
              </a:pPr>
              <a:t>07.01.2015</a:t>
            </a:fld>
            <a:endParaRPr lang="de-CH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DE911A0-E191-EC49-A2B6-F39B69B249D1}" type="slidenum">
              <a:rPr lang="de-CH"/>
              <a:pPr>
                <a:defRPr/>
              </a:pPr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6699128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CH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F695A34-992B-2B48-8C5F-490C5925C01C}" type="datetimeFigureOut">
              <a:rPr lang="de-CH"/>
              <a:pPr>
                <a:defRPr/>
              </a:pPr>
              <a:t>07.01.2015</a:t>
            </a:fld>
            <a:endParaRPr lang="de-CH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4174AFE-87BC-5F49-BE78-BAD43C64D4C8}" type="slidenum">
              <a:rPr lang="de-CH"/>
              <a:pPr>
                <a:defRPr/>
              </a:pPr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9461746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  <a:endParaRPr lang="de-CH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  <a:cs typeface="Arial" charset="0"/>
              </a:defRPr>
            </a:lvl1pPr>
          </a:lstStyle>
          <a:p>
            <a:pPr>
              <a:defRPr/>
            </a:pPr>
            <a:fld id="{3AA7F55C-B592-994E-85C7-D4A135FE45C5}" type="datetimeFigureOut">
              <a:rPr lang="de-CH"/>
              <a:pPr>
                <a:defRPr/>
              </a:pPr>
              <a:t>07.01.201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  <a:cs typeface="Arial" charset="0"/>
              </a:defRPr>
            </a:lvl1pPr>
          </a:lstStyle>
          <a:p>
            <a:pPr>
              <a:defRPr/>
            </a:pPr>
            <a:fld id="{2ED318BE-A981-B64C-8A29-B4B80A5084C4}" type="slidenum">
              <a:rPr lang="de-CH"/>
              <a:pPr>
                <a:defRPr/>
              </a:pPr>
              <a:t>‹#›</a:t>
            </a:fld>
            <a:endParaRPr lang="de-CH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charset="0"/>
          <a:cs typeface="ＭＳ Ｐゴシック" charset="0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ＭＳ Ｐゴシック" charset="0"/>
          <a:cs typeface="ＭＳ Ｐゴシック" charset="0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ＭＳ Ｐゴシック" charset="0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ＭＳ Ｐゴシック" charset="0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ＭＳ Ｐゴシック" charset="0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ＭＳ Ｐゴシック" charset="0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9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9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9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9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1"/>
          <p:cNvSpPr txBox="1">
            <a:spLocks noChangeArrowheads="1"/>
          </p:cNvSpPr>
          <p:nvPr/>
        </p:nvSpPr>
        <p:spPr bwMode="auto">
          <a:xfrm>
            <a:off x="2483768" y="1556792"/>
            <a:ext cx="115721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1pPr>
            <a:lvl2pPr>
              <a:defRPr sz="28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sz="1200">
                <a:latin typeface="Arial"/>
                <a:cs typeface="Arial"/>
              </a:rPr>
              <a:t>Suppl. Table 3 </a:t>
            </a: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3659613"/>
              </p:ext>
            </p:extLst>
          </p:nvPr>
        </p:nvGraphicFramePr>
        <p:xfrm>
          <a:off x="2483768" y="2132856"/>
          <a:ext cx="3384376" cy="1563008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720080"/>
                <a:gridCol w="1872208"/>
                <a:gridCol w="792088"/>
              </a:tblGrid>
              <a:tr h="282848">
                <a:tc>
                  <a:txBody>
                    <a:bodyPr/>
                    <a:lstStyle/>
                    <a:p>
                      <a:r>
                        <a:rPr kumimoji="0" lang="en-US" sz="10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Gene</a:t>
                      </a:r>
                      <a:endParaRPr lang="en-US" sz="1000">
                        <a:latin typeface="Arial"/>
                        <a:cs typeface="Arial"/>
                      </a:endParaRPr>
                    </a:p>
                  </a:txBody>
                  <a:tcP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CH" sz="10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siRNA target sequence</a:t>
                      </a:r>
                    </a:p>
                  </a:txBody>
                  <a:tcP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0" lang="de-CH" sz="10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Organism</a:t>
                      </a:r>
                      <a:endParaRPr lang="en-US" sz="1000">
                        <a:latin typeface="Arial"/>
                        <a:cs typeface="Arial"/>
                      </a:endParaRPr>
                    </a:p>
                  </a:txBody>
                  <a:tcP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3216">
                <a:tc>
                  <a:txBody>
                    <a:bodyPr/>
                    <a:lstStyle/>
                    <a:p>
                      <a:r>
                        <a:rPr kumimoji="0" lang="de-CH" sz="800" b="1" i="1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Elavl1</a:t>
                      </a:r>
                      <a:endParaRPr lang="en-US" sz="800">
                        <a:latin typeface="Arial"/>
                        <a:cs typeface="Arial"/>
                      </a:endParaRPr>
                    </a:p>
                  </a:txBody>
                  <a:tcP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kumimoji="0" lang="en-US" sz="800" b="0" i="0" u="none" strike="noStrike" kern="1200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CTCGCCCAAGCTCAGAGGTTA</a:t>
                      </a:r>
                    </a:p>
                  </a:txBody>
                  <a:tcP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kumimoji="0" lang="de-CH" sz="8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Rn</a:t>
                      </a:r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135880">
                <a:tc>
                  <a:txBody>
                    <a:bodyPr/>
                    <a:lstStyle/>
                    <a:p>
                      <a:r>
                        <a:rPr kumimoji="0" lang="de-CH" sz="800" b="1" i="1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Hnrnpd</a:t>
                      </a:r>
                      <a:endParaRPr lang="en-US" sz="80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AAGATCGACGCCAGTAAGAAT</a:t>
                      </a:r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0" lang="de-CH" sz="8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Rn</a:t>
                      </a:r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/>
                </a:tc>
              </a:tr>
              <a:tr h="138544">
                <a:tc>
                  <a:txBody>
                    <a:bodyPr/>
                    <a:lstStyle/>
                    <a:p>
                      <a:r>
                        <a:rPr kumimoji="0" lang="en-US" sz="800" b="1" i="1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Ilf3 (si1)</a:t>
                      </a:r>
                      <a:endParaRPr lang="en-US" sz="80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CACGGAGGAGGCTACATGAAT</a:t>
                      </a:r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0" lang="de-CH" sz="8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Rn</a:t>
                      </a:r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/>
                </a:tc>
              </a:tr>
              <a:tr h="141208">
                <a:tc>
                  <a:txBody>
                    <a:bodyPr/>
                    <a:lstStyle/>
                    <a:p>
                      <a:r>
                        <a:rPr kumimoji="0" lang="en-US" sz="800" b="1" i="1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Ilf3 (si2)</a:t>
                      </a:r>
                      <a:endParaRPr lang="en-US" sz="80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i="0">
                          <a:latin typeface="Arial"/>
                          <a:cs typeface="Arial"/>
                        </a:rPr>
                        <a:t>CAGGGCAAGCAGAAAGGCTA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0" lang="de-CH" sz="8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Rn</a:t>
                      </a:r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/>
                </a:tc>
              </a:tr>
              <a:tr h="143872">
                <a:tc>
                  <a:txBody>
                    <a:bodyPr/>
                    <a:lstStyle/>
                    <a:p>
                      <a:r>
                        <a:rPr kumimoji="0" lang="en-US" sz="800" b="1" i="1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Khsrp (si1)</a:t>
                      </a:r>
                      <a:endParaRPr lang="en-US" sz="80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0" lang="en-US" sz="8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CTCAGCAGATTGACCATGCAA</a:t>
                      </a:r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0" lang="de-CH" sz="8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Rn</a:t>
                      </a:r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/>
                </a:tc>
              </a:tr>
              <a:tr h="146536">
                <a:tc>
                  <a:txBody>
                    <a:bodyPr/>
                    <a:lstStyle/>
                    <a:p>
                      <a:r>
                        <a:rPr kumimoji="0" lang="en-US" sz="800" b="1" i="1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Khsrp (si2)</a:t>
                      </a:r>
                      <a:endParaRPr lang="en-US" sz="800">
                        <a:latin typeface="Arial"/>
                        <a:cs typeface="Arial"/>
                      </a:endParaRPr>
                    </a:p>
                  </a:txBody>
                  <a:tcPr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800" i="0">
                          <a:latin typeface="Arial"/>
                          <a:cs typeface="Arial"/>
                        </a:rPr>
                        <a:t>CCGCCTGGGCTGAGTATTACA</a:t>
                      </a:r>
                    </a:p>
                  </a:txBody>
                  <a:tcPr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0" lang="de-CH" sz="8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/>
                          <a:ea typeface="ＭＳ Ｐゴシック" charset="0"/>
                          <a:cs typeface="Arial"/>
                        </a:rPr>
                        <a:t>Rn</a:t>
                      </a:r>
                      <a:endParaRPr lang="en-US" sz="800" i="0">
                        <a:latin typeface="Arial"/>
                        <a:cs typeface="Arial"/>
                      </a:endParaRPr>
                    </a:p>
                  </a:txBody>
                  <a:tcPr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PRESGUID" val="24a27946-27ce-4cce-937e-4fb1055063d8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0</Words>
  <Application>Microsoft Office PowerPoint</Application>
  <PresentationFormat>On-screen Show (4:3)</PresentationFormat>
  <Paragraphs>2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Office Theme</vt:lpstr>
      <vt:lpstr>PowerPoint Presentation</vt:lpstr>
    </vt:vector>
  </TitlesOfParts>
  <Company>Inselspital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gca, Cavit</dc:creator>
  <cp:lastModifiedBy>cavit agca</cp:lastModifiedBy>
  <cp:revision>79</cp:revision>
  <cp:lastPrinted>2014-06-19T09:40:11Z</cp:lastPrinted>
  <dcterms:created xsi:type="dcterms:W3CDTF">2014-04-10T08:05:20Z</dcterms:created>
  <dcterms:modified xsi:type="dcterms:W3CDTF">2015-01-07T09:36:31Z</dcterms:modified>
</cp:coreProperties>
</file>